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A6AB0E-9ED7-4DB5-8899-39C0926C84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8A33C-FB76-436D-854D-F04E549216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416BE-CCE0-4838-86D6-6F2721E0B4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1E199-9752-4657-86CB-2C287BB2B3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C0927-0039-49DA-9805-B01C11575C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FB595-5A0B-4903-B940-F00F216EB1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188C8-F39F-4964-B61B-04295C3CA9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1F077-0FAA-477F-8043-E2726BBEF9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2744B-B290-4C04-8CE2-C560BEE4C9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00F78-0C26-446B-ABEC-29B5E7FC22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00F4A-4F97-466C-BB84-D49C018D90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48F3A-8047-4B15-8AEF-5AB0D39A7D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4B2FB7-2142-422D-8B36-F0683BA75C15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Freccia a destra 4"/>
          <p:cNvSpPr/>
          <p:nvPr/>
        </p:nvSpPr>
        <p:spPr>
          <a:xfrm>
            <a:off x="684360" y="1374840"/>
            <a:ext cx="7704000" cy="71280"/>
          </a:xfrm>
          <a:prstGeom prst="rightArrow">
            <a:avLst>
              <a:gd name="adj1" fmla="val 50000"/>
              <a:gd name="adj2" fmla="val 5003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0" bIns="-10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onnettore 1 6"/>
          <p:cNvSpPr/>
          <p:nvPr/>
        </p:nvSpPr>
        <p:spPr>
          <a:xfrm>
            <a:off x="684360" y="140976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CasellaDiTesto 7"/>
          <p:cNvSpPr/>
          <p:nvPr/>
        </p:nvSpPr>
        <p:spPr>
          <a:xfrm>
            <a:off x="472320" y="98100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D1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asellaDiTesto 8"/>
          <p:cNvSpPr/>
          <p:nvPr/>
        </p:nvSpPr>
        <p:spPr>
          <a:xfrm rot="19546800">
            <a:off x="214200" y="1662480"/>
            <a:ext cx="1187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Treatmen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of  Dam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ith VP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or S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onnettore 1 9"/>
          <p:cNvSpPr/>
          <p:nvPr/>
        </p:nvSpPr>
        <p:spPr>
          <a:xfrm>
            <a:off x="133200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asellaDiTesto 10"/>
          <p:cNvSpPr/>
          <p:nvPr/>
        </p:nvSpPr>
        <p:spPr>
          <a:xfrm>
            <a:off x="1119600" y="868320"/>
            <a:ext cx="586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D22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CasellaDiTesto 11"/>
          <p:cNvSpPr/>
          <p:nvPr/>
        </p:nvSpPr>
        <p:spPr>
          <a:xfrm rot="19482600">
            <a:off x="1001160" y="1700640"/>
            <a:ext cx="57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Birth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CasellaDiTesto 15"/>
          <p:cNvSpPr/>
          <p:nvPr/>
        </p:nvSpPr>
        <p:spPr>
          <a:xfrm>
            <a:off x="1766160" y="981000"/>
            <a:ext cx="53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asellaDiTesto 16"/>
          <p:cNvSpPr/>
          <p:nvPr/>
        </p:nvSpPr>
        <p:spPr>
          <a:xfrm rot="19249800">
            <a:off x="1539720" y="1582920"/>
            <a:ext cx="1224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Isolation-induc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USV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17"/>
          <p:cNvSpPr/>
          <p:nvPr/>
        </p:nvSpPr>
        <p:spPr>
          <a:xfrm>
            <a:off x="234324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onnettore 1 18"/>
          <p:cNvSpPr/>
          <p:nvPr/>
        </p:nvSpPr>
        <p:spPr>
          <a:xfrm>
            <a:off x="197964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onnettore 1 19"/>
          <p:cNvSpPr/>
          <p:nvPr/>
        </p:nvSpPr>
        <p:spPr>
          <a:xfrm>
            <a:off x="262728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20"/>
          <p:cNvSpPr/>
          <p:nvPr/>
        </p:nvSpPr>
        <p:spPr>
          <a:xfrm rot="19287600">
            <a:off x="2332080" y="1662120"/>
            <a:ext cx="72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Homin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behavi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21"/>
          <p:cNvSpPr/>
          <p:nvPr/>
        </p:nvSpPr>
        <p:spPr>
          <a:xfrm>
            <a:off x="3135240" y="99216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onnettore 1 22"/>
          <p:cNvSpPr/>
          <p:nvPr/>
        </p:nvSpPr>
        <p:spPr>
          <a:xfrm>
            <a:off x="341964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CasellaDiTesto 23"/>
          <p:cNvSpPr/>
          <p:nvPr/>
        </p:nvSpPr>
        <p:spPr>
          <a:xfrm rot="19057200">
            <a:off x="3011400" y="159660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ean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onnettore 1 25"/>
          <p:cNvSpPr/>
          <p:nvPr/>
        </p:nvSpPr>
        <p:spPr>
          <a:xfrm>
            <a:off x="414036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sellaDiTesto 26"/>
          <p:cNvSpPr/>
          <p:nvPr/>
        </p:nvSpPr>
        <p:spPr>
          <a:xfrm rot="19358400">
            <a:off x="3394080" y="1835280"/>
            <a:ext cx="110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Social Play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sellaDiTesto 27"/>
          <p:cNvSpPr/>
          <p:nvPr/>
        </p:nvSpPr>
        <p:spPr>
          <a:xfrm>
            <a:off x="648036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Connettore 1 28"/>
          <p:cNvSpPr/>
          <p:nvPr/>
        </p:nvSpPr>
        <p:spPr>
          <a:xfrm>
            <a:off x="673272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55"/>
          <p:cNvSpPr/>
          <p:nvPr/>
        </p:nvSpPr>
        <p:spPr>
          <a:xfrm>
            <a:off x="2190600" y="115920"/>
            <a:ext cx="481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  <a:ea typeface="Arial"/>
              </a:rPr>
              <a:t>Behavioral characterization of  VPA- and SAL-exposed  anima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56"/>
          <p:cNvSpPr/>
          <p:nvPr/>
        </p:nvSpPr>
        <p:spPr>
          <a:xfrm>
            <a:off x="2702880" y="2492280"/>
            <a:ext cx="403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  <a:ea typeface="Arial"/>
              </a:rPr>
              <a:t>Effects of URB597 in VPA- and SAL-exposed  anima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102"/>
          <p:cNvSpPr/>
          <p:nvPr/>
        </p:nvSpPr>
        <p:spPr>
          <a:xfrm>
            <a:off x="879120" y="4797360"/>
            <a:ext cx="754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  <a:ea typeface="Arial"/>
              </a:rPr>
              <a:t>Western blot  and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quantitative PCR (qPCR) analyses of  the brain of </a:t>
            </a:r>
            <a:r>
              <a:rPr b="1" lang="it-IT" sz="1400" spc="-1" strike="noStrike">
                <a:solidFill>
                  <a:srgbClr val="000000"/>
                </a:solidFill>
                <a:latin typeface="Calibri"/>
                <a:ea typeface="Arial"/>
              </a:rPr>
              <a:t>VPA- and SAL-exposed  animals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asellaDiTesto 121"/>
          <p:cNvSpPr/>
          <p:nvPr/>
        </p:nvSpPr>
        <p:spPr>
          <a:xfrm rot="19630200">
            <a:off x="3026520" y="5965920"/>
            <a:ext cx="994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estern bl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nd q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sellaDiTesto 21"/>
          <p:cNvSpPr/>
          <p:nvPr/>
        </p:nvSpPr>
        <p:spPr>
          <a:xfrm>
            <a:off x="392436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21"/>
          <p:cNvSpPr/>
          <p:nvPr/>
        </p:nvSpPr>
        <p:spPr>
          <a:xfrm>
            <a:off x="460548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sellaDiTesto 26"/>
          <p:cNvSpPr/>
          <p:nvPr/>
        </p:nvSpPr>
        <p:spPr>
          <a:xfrm rot="19358400">
            <a:off x="4121640" y="180000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3-chamber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onnettore 1 78"/>
          <p:cNvSpPr/>
          <p:nvPr/>
        </p:nvSpPr>
        <p:spPr>
          <a:xfrm>
            <a:off x="493236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asellaDiTesto 21"/>
          <p:cNvSpPr/>
          <p:nvPr/>
        </p:nvSpPr>
        <p:spPr>
          <a:xfrm>
            <a:off x="522288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onnettore 1 81"/>
          <p:cNvSpPr/>
          <p:nvPr/>
        </p:nvSpPr>
        <p:spPr>
          <a:xfrm>
            <a:off x="550872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asellaDiTesto 26"/>
          <p:cNvSpPr/>
          <p:nvPr/>
        </p:nvSpPr>
        <p:spPr>
          <a:xfrm rot="19358400">
            <a:off x="4610520" y="1892160"/>
            <a:ext cx="115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Hole-board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asellaDiTesto 21"/>
          <p:cNvSpPr/>
          <p:nvPr/>
        </p:nvSpPr>
        <p:spPr>
          <a:xfrm>
            <a:off x="579924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onnettore 1 85"/>
          <p:cNvSpPr/>
          <p:nvPr/>
        </p:nvSpPr>
        <p:spPr>
          <a:xfrm>
            <a:off x="601200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asellaDiTesto 26"/>
          <p:cNvSpPr/>
          <p:nvPr/>
        </p:nvSpPr>
        <p:spPr>
          <a:xfrm rot="19358400">
            <a:off x="5519880" y="173052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EPM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sellaDiTesto 26"/>
          <p:cNvSpPr/>
          <p:nvPr/>
        </p:nvSpPr>
        <p:spPr>
          <a:xfrm rot="19358400">
            <a:off x="5921640" y="187236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3-chamber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asellaDiTesto 26"/>
          <p:cNvSpPr/>
          <p:nvPr/>
        </p:nvSpPr>
        <p:spPr>
          <a:xfrm rot="19358400">
            <a:off x="6483960" y="1880640"/>
            <a:ext cx="115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Hole-board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CasellaDiTesto 26"/>
          <p:cNvSpPr/>
          <p:nvPr/>
        </p:nvSpPr>
        <p:spPr>
          <a:xfrm rot="19358400">
            <a:off x="7496280" y="173052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EPM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asellaDiTesto 27"/>
          <p:cNvSpPr/>
          <p:nvPr/>
        </p:nvSpPr>
        <p:spPr>
          <a:xfrm>
            <a:off x="719784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asellaDiTesto 27"/>
          <p:cNvSpPr/>
          <p:nvPr/>
        </p:nvSpPr>
        <p:spPr>
          <a:xfrm>
            <a:off x="7774200" y="98100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onnettore 1 93"/>
          <p:cNvSpPr/>
          <p:nvPr/>
        </p:nvSpPr>
        <p:spPr>
          <a:xfrm>
            <a:off x="738036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onnettore 1 94"/>
          <p:cNvSpPr/>
          <p:nvPr/>
        </p:nvSpPr>
        <p:spPr>
          <a:xfrm>
            <a:off x="7956720" y="14130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arentesi graffa aperta 95"/>
          <p:cNvSpPr/>
          <p:nvPr/>
        </p:nvSpPr>
        <p:spPr>
          <a:xfrm rot="5400000">
            <a:off x="7199640" y="8280"/>
            <a:ext cx="287640" cy="1800360"/>
          </a:xfrm>
          <a:custGeom>
            <a:avLst/>
            <a:gdLst>
              <a:gd name="textAreaLeft" fmla="*/ 183960 w 287640"/>
              <a:gd name="textAreaRight" fmla="*/ 288000 w 287640"/>
              <a:gd name="textAreaTop" fmla="*/ 33840 h 1800360"/>
              <a:gd name="textAreaBottom" fmla="*/ 1766520 h 1800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49"/>
                  <a:pt x="10800" y="1298"/>
                </a:cubicBezTo>
                <a:lnTo>
                  <a:pt x="10800" y="9126"/>
                </a:lnTo>
                <a:cubicBezTo>
                  <a:pt x="10800" y="9775"/>
                  <a:pt x="5400" y="10424"/>
                  <a:pt x="0" y="10424"/>
                </a:cubicBezTo>
                <a:cubicBezTo>
                  <a:pt x="5400" y="10424"/>
                  <a:pt x="10800" y="11073"/>
                  <a:pt x="10800" y="11722"/>
                </a:cubicBezTo>
                <a:lnTo>
                  <a:pt x="10800" y="20302"/>
                </a:lnTo>
                <a:cubicBezTo>
                  <a:pt x="10800" y="20951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11"/>
          <p:cNvSpPr/>
          <p:nvPr/>
        </p:nvSpPr>
        <p:spPr>
          <a:xfrm>
            <a:off x="4722480" y="476280"/>
            <a:ext cx="96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dolesce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arentesi graffa aperta 97"/>
          <p:cNvSpPr/>
          <p:nvPr/>
        </p:nvSpPr>
        <p:spPr>
          <a:xfrm rot="5400000">
            <a:off x="4913280" y="-369720"/>
            <a:ext cx="477720" cy="2602080"/>
          </a:xfrm>
          <a:custGeom>
            <a:avLst/>
            <a:gdLst>
              <a:gd name="textAreaLeft" fmla="*/ 305280 w 477720"/>
              <a:gd name="textAreaRight" fmla="*/ 478080 w 477720"/>
              <a:gd name="textAreaTop" fmla="*/ 12240 h 2602080"/>
              <a:gd name="textAreaBottom" fmla="*/ 2589840 h 26020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66"/>
                  <a:pt x="10800" y="331"/>
                </a:cubicBezTo>
                <a:lnTo>
                  <a:pt x="10800" y="10245"/>
                </a:lnTo>
                <a:cubicBezTo>
                  <a:pt x="10800" y="10411"/>
                  <a:pt x="5400" y="10576"/>
                  <a:pt x="0" y="10576"/>
                </a:cubicBezTo>
                <a:cubicBezTo>
                  <a:pt x="5400" y="10576"/>
                  <a:pt x="10800" y="10742"/>
                  <a:pt x="10800" y="10907"/>
                </a:cubicBezTo>
                <a:lnTo>
                  <a:pt x="10800" y="21269"/>
                </a:lnTo>
                <a:cubicBezTo>
                  <a:pt x="10800" y="21435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CasellaDiTesto 11"/>
          <p:cNvSpPr/>
          <p:nvPr/>
        </p:nvSpPr>
        <p:spPr>
          <a:xfrm>
            <a:off x="6969960" y="47628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dulthoo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ccia a destra 99"/>
          <p:cNvSpPr/>
          <p:nvPr/>
        </p:nvSpPr>
        <p:spPr>
          <a:xfrm>
            <a:off x="706320" y="3705120"/>
            <a:ext cx="7704360" cy="71640"/>
          </a:xfrm>
          <a:prstGeom prst="rightArrow">
            <a:avLst>
              <a:gd name="adj1" fmla="val 50000"/>
              <a:gd name="adj2" fmla="val 49788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0" bIns="-10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Connettore 1 100"/>
          <p:cNvSpPr/>
          <p:nvPr/>
        </p:nvSpPr>
        <p:spPr>
          <a:xfrm>
            <a:off x="706320" y="374004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CasellaDiTesto 7"/>
          <p:cNvSpPr/>
          <p:nvPr/>
        </p:nvSpPr>
        <p:spPr>
          <a:xfrm>
            <a:off x="494640" y="331164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D1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CasellaDiTesto 8"/>
          <p:cNvSpPr/>
          <p:nvPr/>
        </p:nvSpPr>
        <p:spPr>
          <a:xfrm rot="19546800">
            <a:off x="236160" y="3992400"/>
            <a:ext cx="1187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Treatmen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of  Dam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ith VP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or S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Connettore 1 103"/>
          <p:cNvSpPr/>
          <p:nvPr/>
        </p:nvSpPr>
        <p:spPr>
          <a:xfrm>
            <a:off x="135396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CasellaDiTesto 10"/>
          <p:cNvSpPr/>
          <p:nvPr/>
        </p:nvSpPr>
        <p:spPr>
          <a:xfrm>
            <a:off x="1141920" y="3198960"/>
            <a:ext cx="586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D22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CasellaDiTesto 11"/>
          <p:cNvSpPr/>
          <p:nvPr/>
        </p:nvSpPr>
        <p:spPr>
          <a:xfrm rot="19482600">
            <a:off x="1023480" y="4030560"/>
            <a:ext cx="57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Birth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CasellaDiTesto 15"/>
          <p:cNvSpPr/>
          <p:nvPr/>
        </p:nvSpPr>
        <p:spPr>
          <a:xfrm>
            <a:off x="1788480" y="3311640"/>
            <a:ext cx="53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CasellaDiTesto 16"/>
          <p:cNvSpPr/>
          <p:nvPr/>
        </p:nvSpPr>
        <p:spPr>
          <a:xfrm rot="19249800">
            <a:off x="1562040" y="3913560"/>
            <a:ext cx="1223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Isolation-induc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USV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CasellaDiTesto 17"/>
          <p:cNvSpPr/>
          <p:nvPr/>
        </p:nvSpPr>
        <p:spPr>
          <a:xfrm>
            <a:off x="2365560" y="331164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Connettore 1 109"/>
          <p:cNvSpPr/>
          <p:nvPr/>
        </p:nvSpPr>
        <p:spPr>
          <a:xfrm>
            <a:off x="200196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Connettore 1 110"/>
          <p:cNvSpPr/>
          <p:nvPr/>
        </p:nvSpPr>
        <p:spPr>
          <a:xfrm>
            <a:off x="264960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CasellaDiTesto 20"/>
          <p:cNvSpPr/>
          <p:nvPr/>
        </p:nvSpPr>
        <p:spPr>
          <a:xfrm rot="19287600">
            <a:off x="2354400" y="3994200"/>
            <a:ext cx="72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Homin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behavi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CasellaDiTesto 21"/>
          <p:cNvSpPr/>
          <p:nvPr/>
        </p:nvSpPr>
        <p:spPr>
          <a:xfrm>
            <a:off x="3157560" y="332424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Connettore 1 113"/>
          <p:cNvSpPr/>
          <p:nvPr/>
        </p:nvSpPr>
        <p:spPr>
          <a:xfrm>
            <a:off x="344160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CasellaDiTesto 23"/>
          <p:cNvSpPr/>
          <p:nvPr/>
        </p:nvSpPr>
        <p:spPr>
          <a:xfrm rot="19057200">
            <a:off x="3033720" y="392724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ean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onnettore 1 115"/>
          <p:cNvSpPr/>
          <p:nvPr/>
        </p:nvSpPr>
        <p:spPr>
          <a:xfrm>
            <a:off x="416232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CasellaDiTesto 26"/>
          <p:cNvSpPr/>
          <p:nvPr/>
        </p:nvSpPr>
        <p:spPr>
          <a:xfrm rot="19106400">
            <a:off x="3416040" y="4167000"/>
            <a:ext cx="110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Social Play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Connettore 1 118"/>
          <p:cNvSpPr/>
          <p:nvPr/>
        </p:nvSpPr>
        <p:spPr>
          <a:xfrm>
            <a:off x="675468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CasellaDiTesto 26"/>
          <p:cNvSpPr/>
          <p:nvPr/>
        </p:nvSpPr>
        <p:spPr>
          <a:xfrm rot="19358400">
            <a:off x="4144320" y="413172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3-chamber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onnettore 1 123"/>
          <p:cNvSpPr/>
          <p:nvPr/>
        </p:nvSpPr>
        <p:spPr>
          <a:xfrm>
            <a:off x="495468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Connettore 1 125"/>
          <p:cNvSpPr/>
          <p:nvPr/>
        </p:nvSpPr>
        <p:spPr>
          <a:xfrm>
            <a:off x="553068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CasellaDiTesto 26"/>
          <p:cNvSpPr/>
          <p:nvPr/>
        </p:nvSpPr>
        <p:spPr>
          <a:xfrm rot="19358400">
            <a:off x="4632840" y="4222800"/>
            <a:ext cx="115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Hole-board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Connettore 1 128"/>
          <p:cNvSpPr/>
          <p:nvPr/>
        </p:nvSpPr>
        <p:spPr>
          <a:xfrm>
            <a:off x="603396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CasellaDiTesto 26"/>
          <p:cNvSpPr/>
          <p:nvPr/>
        </p:nvSpPr>
        <p:spPr>
          <a:xfrm rot="19358400">
            <a:off x="5541840" y="406080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EPM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CasellaDiTesto 26"/>
          <p:cNvSpPr/>
          <p:nvPr/>
        </p:nvSpPr>
        <p:spPr>
          <a:xfrm rot="19358400">
            <a:off x="5943600" y="4203360"/>
            <a:ext cx="11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3-chamber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CasellaDiTesto 26"/>
          <p:cNvSpPr/>
          <p:nvPr/>
        </p:nvSpPr>
        <p:spPr>
          <a:xfrm rot="19358400">
            <a:off x="6506640" y="4210920"/>
            <a:ext cx="115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Hole-board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asellaDiTesto 26"/>
          <p:cNvSpPr/>
          <p:nvPr/>
        </p:nvSpPr>
        <p:spPr>
          <a:xfrm rot="19358400">
            <a:off x="7519320" y="406116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EPM t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Connettore 1 135"/>
          <p:cNvSpPr/>
          <p:nvPr/>
        </p:nvSpPr>
        <p:spPr>
          <a:xfrm>
            <a:off x="740268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Connettore 1 136"/>
          <p:cNvSpPr/>
          <p:nvPr/>
        </p:nvSpPr>
        <p:spPr>
          <a:xfrm>
            <a:off x="7978680" y="374328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arentesi graffa aperta 137"/>
          <p:cNvSpPr/>
          <p:nvPr/>
        </p:nvSpPr>
        <p:spPr>
          <a:xfrm rot="5400000">
            <a:off x="7222320" y="2339280"/>
            <a:ext cx="287280" cy="1800000"/>
          </a:xfrm>
          <a:custGeom>
            <a:avLst/>
            <a:gdLst>
              <a:gd name="textAreaLeft" fmla="*/ 183600 w 287280"/>
              <a:gd name="textAreaRight" fmla="*/ 287640 w 287280"/>
              <a:gd name="textAreaTop" fmla="*/ 33840 h 1800000"/>
              <a:gd name="textAreaBottom" fmla="*/ 1766160 h 1800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49"/>
                  <a:pt x="10800" y="1298"/>
                </a:cubicBezTo>
                <a:lnTo>
                  <a:pt x="10800" y="9126"/>
                </a:lnTo>
                <a:cubicBezTo>
                  <a:pt x="10800" y="9775"/>
                  <a:pt x="5400" y="10424"/>
                  <a:pt x="0" y="10424"/>
                </a:cubicBezTo>
                <a:cubicBezTo>
                  <a:pt x="5400" y="10424"/>
                  <a:pt x="10800" y="11073"/>
                  <a:pt x="10800" y="11722"/>
                </a:cubicBezTo>
                <a:lnTo>
                  <a:pt x="10800" y="20302"/>
                </a:lnTo>
                <a:cubicBezTo>
                  <a:pt x="10800" y="20951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CasellaDiTesto 11"/>
          <p:cNvSpPr/>
          <p:nvPr/>
        </p:nvSpPr>
        <p:spPr>
          <a:xfrm>
            <a:off x="4744800" y="2808360"/>
            <a:ext cx="96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dolesce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arentesi graffa aperta 139"/>
          <p:cNvSpPr/>
          <p:nvPr/>
        </p:nvSpPr>
        <p:spPr>
          <a:xfrm rot="5400000">
            <a:off x="4935960" y="1961280"/>
            <a:ext cx="475920" cy="2601720"/>
          </a:xfrm>
          <a:custGeom>
            <a:avLst/>
            <a:gdLst>
              <a:gd name="textAreaLeft" fmla="*/ 304200 w 475920"/>
              <a:gd name="textAreaRight" fmla="*/ 476280 w 475920"/>
              <a:gd name="textAreaTop" fmla="*/ 12240 h 2601720"/>
              <a:gd name="textAreaBottom" fmla="*/ 2589480 h 2601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65"/>
                  <a:pt x="10800" y="329"/>
                </a:cubicBezTo>
                <a:lnTo>
                  <a:pt x="10800" y="10247"/>
                </a:lnTo>
                <a:cubicBezTo>
                  <a:pt x="10800" y="10412"/>
                  <a:pt x="5400" y="10576"/>
                  <a:pt x="0" y="10576"/>
                </a:cubicBezTo>
                <a:cubicBezTo>
                  <a:pt x="5400" y="10576"/>
                  <a:pt x="10800" y="10741"/>
                  <a:pt x="10800" y="10905"/>
                </a:cubicBezTo>
                <a:lnTo>
                  <a:pt x="10800" y="21271"/>
                </a:lnTo>
                <a:cubicBezTo>
                  <a:pt x="10800" y="21436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CasellaDiTesto 11"/>
          <p:cNvSpPr/>
          <p:nvPr/>
        </p:nvSpPr>
        <p:spPr>
          <a:xfrm>
            <a:off x="6992280" y="280836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dulthoo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ccia a destra 182"/>
          <p:cNvSpPr/>
          <p:nvPr/>
        </p:nvSpPr>
        <p:spPr>
          <a:xfrm>
            <a:off x="755640" y="5689440"/>
            <a:ext cx="7704000" cy="71640"/>
          </a:xfrm>
          <a:prstGeom prst="rightArrow">
            <a:avLst>
              <a:gd name="adj1" fmla="val 50000"/>
              <a:gd name="adj2" fmla="val 49786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0" bIns="-10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Connettore 1 183"/>
          <p:cNvSpPr/>
          <p:nvPr/>
        </p:nvSpPr>
        <p:spPr>
          <a:xfrm>
            <a:off x="755640" y="5724360"/>
            <a:ext cx="0" cy="2527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CasellaDiTesto 7"/>
          <p:cNvSpPr/>
          <p:nvPr/>
        </p:nvSpPr>
        <p:spPr>
          <a:xfrm>
            <a:off x="543600" y="529596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D1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CasellaDiTesto 8"/>
          <p:cNvSpPr/>
          <p:nvPr/>
        </p:nvSpPr>
        <p:spPr>
          <a:xfrm rot="19546800">
            <a:off x="371520" y="5867280"/>
            <a:ext cx="1187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Treatmen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of  Dams  with VPA  or S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Connettore 1 186"/>
          <p:cNvSpPr/>
          <p:nvPr/>
        </p:nvSpPr>
        <p:spPr>
          <a:xfrm>
            <a:off x="2195640" y="57276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CasellaDiTesto 10"/>
          <p:cNvSpPr/>
          <p:nvPr/>
        </p:nvSpPr>
        <p:spPr>
          <a:xfrm>
            <a:off x="1965960" y="5183280"/>
            <a:ext cx="586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D22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CasellaDiTesto 11"/>
          <p:cNvSpPr/>
          <p:nvPr/>
        </p:nvSpPr>
        <p:spPr>
          <a:xfrm rot="19482600">
            <a:off x="1947600" y="6014880"/>
            <a:ext cx="57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Birth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CasellaDiTesto 17"/>
          <p:cNvSpPr/>
          <p:nvPr/>
        </p:nvSpPr>
        <p:spPr>
          <a:xfrm>
            <a:off x="3206880" y="529596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Connettore 1 193"/>
          <p:cNvSpPr/>
          <p:nvPr/>
        </p:nvSpPr>
        <p:spPr>
          <a:xfrm>
            <a:off x="3492360" y="57276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CasellaDiTesto 21"/>
          <p:cNvSpPr/>
          <p:nvPr/>
        </p:nvSpPr>
        <p:spPr>
          <a:xfrm>
            <a:off x="4319640" y="530856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Connettore 1 196"/>
          <p:cNvSpPr/>
          <p:nvPr/>
        </p:nvSpPr>
        <p:spPr>
          <a:xfrm>
            <a:off x="4572000" y="57276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CasellaDiTesto 23"/>
          <p:cNvSpPr/>
          <p:nvPr/>
        </p:nvSpPr>
        <p:spPr>
          <a:xfrm rot="19628400">
            <a:off x="4149720" y="5911560"/>
            <a:ext cx="10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ean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Connettore 1 198"/>
          <p:cNvSpPr/>
          <p:nvPr/>
        </p:nvSpPr>
        <p:spPr>
          <a:xfrm>
            <a:off x="6012000" y="572760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CasellaDiTesto 27"/>
          <p:cNvSpPr/>
          <p:nvPr/>
        </p:nvSpPr>
        <p:spPr>
          <a:xfrm>
            <a:off x="7527960" y="530064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CasellaDiTesto 21"/>
          <p:cNvSpPr/>
          <p:nvPr/>
        </p:nvSpPr>
        <p:spPr>
          <a:xfrm>
            <a:off x="5688000" y="530064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Connettore 1 205"/>
          <p:cNvSpPr/>
          <p:nvPr/>
        </p:nvSpPr>
        <p:spPr>
          <a:xfrm>
            <a:off x="7885080" y="5732640"/>
            <a:ext cx="0" cy="2523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CasellaDiTesto 121"/>
          <p:cNvSpPr/>
          <p:nvPr/>
        </p:nvSpPr>
        <p:spPr>
          <a:xfrm rot="19630200">
            <a:off x="5552280" y="5965920"/>
            <a:ext cx="994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estern bl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nd q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CasellaDiTesto 121"/>
          <p:cNvSpPr/>
          <p:nvPr/>
        </p:nvSpPr>
        <p:spPr>
          <a:xfrm rot="19630200">
            <a:off x="7419240" y="5965920"/>
            <a:ext cx="994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Western bl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and q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CasellaDiTesto 27"/>
          <p:cNvSpPr/>
          <p:nvPr/>
        </p:nvSpPr>
        <p:spPr>
          <a:xfrm>
            <a:off x="648180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CasellaDiTesto 21"/>
          <p:cNvSpPr/>
          <p:nvPr/>
        </p:nvSpPr>
        <p:spPr>
          <a:xfrm>
            <a:off x="392580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CasellaDiTesto 21"/>
          <p:cNvSpPr/>
          <p:nvPr/>
        </p:nvSpPr>
        <p:spPr>
          <a:xfrm>
            <a:off x="460692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CasellaDiTesto 21"/>
          <p:cNvSpPr/>
          <p:nvPr/>
        </p:nvSpPr>
        <p:spPr>
          <a:xfrm>
            <a:off x="522468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CasellaDiTesto 21"/>
          <p:cNvSpPr/>
          <p:nvPr/>
        </p:nvSpPr>
        <p:spPr>
          <a:xfrm>
            <a:off x="580068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CasellaDiTesto 27"/>
          <p:cNvSpPr/>
          <p:nvPr/>
        </p:nvSpPr>
        <p:spPr>
          <a:xfrm>
            <a:off x="719928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CasellaDiTesto 27"/>
          <p:cNvSpPr/>
          <p:nvPr/>
        </p:nvSpPr>
        <p:spPr>
          <a:xfrm>
            <a:off x="7775640" y="3368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PND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08T08:40:31Z</dcterms:created>
  <dc:creator>Michela</dc:creator>
  <dc:description/>
  <dc:language>en-US</dc:language>
  <cp:lastModifiedBy>Viviana Trezza</cp:lastModifiedBy>
  <dcterms:modified xsi:type="dcterms:W3CDTF">2016-06-13T08:09:02Z</dcterms:modified>
  <cp:revision>43</cp:revision>
  <dc:subject/>
  <dc:title>Diapositiva 1</dc:title>
</cp:coreProperties>
</file>